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51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33"/>
    <a:srgbClr val="4472C4"/>
    <a:srgbClr val="FFC000"/>
    <a:srgbClr val="41719C"/>
    <a:srgbClr val="FFFD49"/>
    <a:srgbClr val="FFFFFF"/>
    <a:srgbClr val="2BD3D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627" autoAdjust="0"/>
    <p:restoredTop sz="90427" autoAdjust="0"/>
  </p:normalViewPr>
  <p:slideViewPr>
    <p:cSldViewPr snapToGrid="0">
      <p:cViewPr varScale="1">
        <p:scale>
          <a:sx n="106" d="100"/>
          <a:sy n="106" d="100"/>
        </p:scale>
        <p:origin x="2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9EC18-D092-4B89-9BF3-58570DF554F1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DF396-80AF-41DF-886C-80F934A7099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4689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0DF396-80AF-41DF-886C-80F934A7099C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9943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004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1058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148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4488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0692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0866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3351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8777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5947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1606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0676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555A5-ED14-4514-B39C-D455DF6365D6}" type="datetimeFigureOut">
              <a:rPr lang="fr-FR" smtClean="0"/>
              <a:t>18/04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764D5-A86D-4582-8FAC-D9C1748A16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2413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ZoneTexte 10">
            <a:extLst>
              <a:ext uri="{FF2B5EF4-FFF2-40B4-BE49-F238E27FC236}">
                <a16:creationId xmlns:a16="http://schemas.microsoft.com/office/drawing/2014/main" id="{E4D0A0FD-4248-35B0-D6C1-E6B28D851BF8}"/>
              </a:ext>
            </a:extLst>
          </p:cNvPr>
          <p:cNvSpPr txBox="1"/>
          <p:nvPr/>
        </p:nvSpPr>
        <p:spPr>
          <a:xfrm>
            <a:off x="457874" y="349372"/>
            <a:ext cx="39711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Table S1: </a:t>
            </a:r>
            <a:r>
              <a:rPr lang="en-GB" dirty="0"/>
              <a:t>Kera-Diet® amino acid profile </a:t>
            </a:r>
            <a:r>
              <a:rPr lang="fr-FR" dirty="0"/>
              <a:t> </a:t>
            </a:r>
          </a:p>
        </p:txBody>
      </p:sp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F195F2F8-D4A6-9318-F569-C1F255C78C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1432368"/>
              </p:ext>
            </p:extLst>
          </p:nvPr>
        </p:nvGraphicFramePr>
        <p:xfrm>
          <a:off x="457874" y="944745"/>
          <a:ext cx="4492709" cy="324377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22354">
                  <a:extLst>
                    <a:ext uri="{9D8B030D-6E8A-4147-A177-3AD203B41FA5}">
                      <a16:colId xmlns:a16="http://schemas.microsoft.com/office/drawing/2014/main" val="2887573325"/>
                    </a:ext>
                  </a:extLst>
                </a:gridCol>
                <a:gridCol w="838767">
                  <a:extLst>
                    <a:ext uri="{9D8B030D-6E8A-4147-A177-3AD203B41FA5}">
                      <a16:colId xmlns:a16="http://schemas.microsoft.com/office/drawing/2014/main" val="2161121220"/>
                    </a:ext>
                  </a:extLst>
                </a:gridCol>
                <a:gridCol w="1031588">
                  <a:extLst>
                    <a:ext uri="{9D8B030D-6E8A-4147-A177-3AD203B41FA5}">
                      <a16:colId xmlns:a16="http://schemas.microsoft.com/office/drawing/2014/main" val="1904888730"/>
                    </a:ext>
                  </a:extLst>
                </a:gridCol>
              </a:tblGrid>
              <a:tr h="329121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fr-FR" sz="1000" b="1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Kera-Diet (average)</a:t>
                      </a:r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Kera-Diet </a:t>
                      </a:r>
                      <a:br>
                        <a:rPr lang="fr-FR" sz="1000" u="none" strike="noStrike">
                          <a:effectLst/>
                        </a:rPr>
                      </a:br>
                      <a:r>
                        <a:rPr lang="fr-FR" sz="1000" u="none" strike="noStrike">
                          <a:effectLst/>
                        </a:rPr>
                        <a:t>Clinical batch</a:t>
                      </a:r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7403274"/>
                  </a:ext>
                </a:extLst>
              </a:tr>
              <a:tr h="159574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Total Amino Acids (%)</a:t>
                      </a:r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88,98</a:t>
                      </a:r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91,86</a:t>
                      </a:r>
                      <a:endParaRPr lang="fr-FR" sz="100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35222367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Ser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11,56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11,99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79619138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Glutamic Acid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10,13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10,91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26998653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Prol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9,6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9,61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5089075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Val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7,2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7,61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42584836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Glyc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7,73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7,59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6719755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Aspartic Acid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6,99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7,35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2538540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Leuc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6,54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6,5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84562313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Argin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5,45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5,92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96990032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Cyst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5,53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5,03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73436729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Threon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4,48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4,68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64183493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Alan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4,65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4,67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3984233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Isoleuc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3,88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4,1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77951987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 err="1">
                          <a:effectLst/>
                        </a:rPr>
                        <a:t>Phenylalan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2,27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2,43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2897629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Lys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1,75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2,04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3873704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Histid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0,59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0,66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8679792"/>
                  </a:ext>
                </a:extLst>
              </a:tr>
              <a:tr h="15106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Methionine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0,37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0,40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47403516"/>
                  </a:ext>
                </a:extLst>
              </a:tr>
              <a:tr h="159574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Tyrosine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>
                          <a:effectLst/>
                        </a:rPr>
                        <a:t>0,27</a:t>
                      </a:r>
                      <a:endParaRPr lang="fr-FR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>
                        <a:buNone/>
                      </a:pPr>
                      <a:r>
                        <a:rPr lang="fr-FR" sz="1000" u="none" strike="noStrike" dirty="0">
                          <a:effectLst/>
                        </a:rPr>
                        <a:t>0,37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66823801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7DABF6DE-C022-BAA7-C790-C23446B6F90E}"/>
              </a:ext>
            </a:extLst>
          </p:cNvPr>
          <p:cNvSpPr txBox="1"/>
          <p:nvPr/>
        </p:nvSpPr>
        <p:spPr>
          <a:xfrm>
            <a:off x="392416" y="4414557"/>
            <a:ext cx="6966967" cy="16663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  <a:buNone/>
            </a:pPr>
            <a:r>
              <a:rPr lang="en-GB" dirty="0"/>
              <a:t>Relative quantification of the amino-acids present in Kera-Diet® expressed in percentage of the mass of the ingredient. Kera-Diet® is composed of 17 different amino-acids. Kera-Diet® (average) represents a typical profile of the ingredient. Kera-Diet® (clinical batch) represents le profile of the ingredient that was specifically used for the study.</a:t>
            </a:r>
            <a:endParaRPr lang="en-GB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91723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31</TotalTime>
  <Words>137</Words>
  <Application>Microsoft Macintosh PowerPoint</Application>
  <PresentationFormat>Grand écran</PresentationFormat>
  <Paragraphs>59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ptos</vt:lpstr>
      <vt:lpstr>Aptos Narrow</vt:lpstr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hann Wittrant</dc:creator>
  <cp:lastModifiedBy>yohann wittrant</cp:lastModifiedBy>
  <cp:revision>332</cp:revision>
  <dcterms:created xsi:type="dcterms:W3CDTF">2019-11-22T14:16:31Z</dcterms:created>
  <dcterms:modified xsi:type="dcterms:W3CDTF">2026-04-18T00:55:41Z</dcterms:modified>
</cp:coreProperties>
</file>